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  <p:sldId id="299" r:id="rId3"/>
    <p:sldId id="300" r:id="rId4"/>
    <p:sldId id="257" r:id="rId5"/>
    <p:sldId id="302" r:id="rId6"/>
    <p:sldId id="258" r:id="rId7"/>
    <p:sldId id="260" r:id="rId8"/>
    <p:sldId id="261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301" r:id="rId20"/>
    <p:sldId id="303" r:id="rId21"/>
    <p:sldId id="277" r:id="rId22"/>
    <p:sldId id="281" r:id="rId23"/>
    <p:sldId id="295" r:id="rId24"/>
    <p:sldId id="287" r:id="rId25"/>
    <p:sldId id="259" r:id="rId26"/>
    <p:sldId id="262" r:id="rId27"/>
    <p:sldId id="273" r:id="rId28"/>
    <p:sldId id="283" r:id="rId29"/>
    <p:sldId id="282" r:id="rId30"/>
    <p:sldId id="292" r:id="rId31"/>
    <p:sldId id="275" r:id="rId32"/>
    <p:sldId id="279" r:id="rId33"/>
    <p:sldId id="284" r:id="rId34"/>
    <p:sldId id="278" r:id="rId35"/>
    <p:sldId id="280" r:id="rId36"/>
    <p:sldId id="285" r:id="rId37"/>
    <p:sldId id="286" r:id="rId38"/>
    <p:sldId id="289" r:id="rId39"/>
    <p:sldId id="291" r:id="rId40"/>
    <p:sldId id="290" r:id="rId41"/>
    <p:sldId id="293" r:id="rId42"/>
    <p:sldId id="294" r:id="rId4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D42362-0AC3-49EF-8F6A-1A244548AE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0A4ABE-36BE-41AF-BBE5-5AF1D86E0C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5CFFE-DE58-4393-8608-75BE6A66D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69A73-9137-4DE6-AF4C-8738F87E6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3999A4-BA35-41A1-87DE-ABB7CF884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936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64698-6DA5-4119-B31D-5E359815FA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45C185-E7CF-4502-B32C-5D6CF2D0F7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C696A7-9530-4E4B-BE5F-FD9716173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935594-EE3F-4C4C-B048-FCC4F17A6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69DF6B-DC71-401F-817D-3E3B5C80B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61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2A02DE-2250-4D0F-B25B-FD11B8C51A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0F3ACD-A3D7-4112-8B13-0BEE771DD2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FF575D-6220-42A0-A5AB-E1FD7AC99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2B22A9-279E-4AE2-8183-A263A0DBF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FE262-B934-4145-AF5F-0458E43A8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303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DB856-B0AD-40C4-8C79-6CF9065EA6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A3632-88F3-40CC-B540-97F712D41B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623701-4F90-41C4-A1D3-4212962E7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CB6E41-E6A1-4473-AB32-0FB7B9251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613D4F-1C8A-4B1A-B005-BFDF74052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58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713D1-C865-416A-BDFA-6C8045369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E5883B-2F84-463B-856B-44F9E21BD5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5813F8-37EB-40CE-990E-61579EAD6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E198E4-9ED0-435E-BADB-EEB7A9E78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B7F7B8-0BCC-4FD2-BFBC-9015F2128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995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02E55A-16ED-4E85-8BF5-A4CD9D01A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C5C3C5-E14C-4819-AC0A-0335C02E15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713F11-BC2D-45DB-97E3-E16DEEBA42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DB3839-2379-494D-925D-8CBBB5C80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1E8BB6-344E-43CF-B77E-B9EC70013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3C60C0-BEF3-409A-9308-33CD20592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888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EBAFB-8DAC-44FA-A938-51F0558D4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551183-11B2-4221-B194-F28DA10266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3D5438-733A-4863-BF1E-E82CA9604C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087358-B8D5-4D7D-933F-2E0670F640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C43EFA-F9F6-4FB8-8011-12BBBFFFE2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F7C239-BA32-468D-91A5-DF08D6A21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CB26FF-C7D5-4724-B7E1-5418D5497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EEEBF1-BD8A-4ECA-8DEA-49E869CB3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358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DBCE4-6C00-42D9-9A64-74468829C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1DFF6D-FB28-4854-A4F9-C46758C13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A0CD81-419A-476B-8C97-2DF31F5CD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18E59B-FC23-4810-9D35-A9656006A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150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D6FE5C-7D69-49C7-8C6A-5D1D504E3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4395E8-4A8B-47A5-936B-DAC274A1F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300324-136D-411F-B833-CF0120AD3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407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83205-0BE9-4F47-B0E6-3B1350CD88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5530AF-1F49-48BC-A158-EB2B98F2A5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B41974-ACD5-4B01-9F7F-08520FBF93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D96354-F815-47E3-B51D-5140DAB50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AE1235-B196-4176-B2FA-5D95876D5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897D16-5F3A-4081-87D8-FFD51ABBC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66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B4B6D0-7292-446C-A59E-5E8FF58C3F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0F2E20-4C38-4843-A754-AF400DFA85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309AB1-C7B2-4CD4-962D-589CDF104B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D61D6F-C4E8-44BC-AADD-081C46E3B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8195A2-1258-4B4A-890B-3FF9AEABE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331E93-0F36-4529-B1B6-200972628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184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A2DB19-0DB4-4800-9A64-98A80FE0D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F9F4A7-9737-40B6-894A-FB2965BFCD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92C725-021C-4148-80A6-3EE6C5DD8B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33EBA9-2EF8-4A0C-BED6-F6031677C3DE}" type="datetimeFigureOut">
              <a:rPr lang="en-US" smtClean="0"/>
              <a:t>8/2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76B4CE-8F60-4DBE-81C7-2CC22DD569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988B6-50B8-472A-9BCB-3ED3D7BD96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771A7-E312-4A6E-BB89-634EBE8A78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029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EC3D9-8175-4FAB-99F4-2639C3CAB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/>
          <a:lstStyle/>
          <a:p>
            <a:r>
              <a:rPr lang="en-US" dirty="0"/>
              <a:t>21 Modified N-glyca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C07F59-CFB3-40E6-94C7-CAE4793790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96241" y="1320166"/>
            <a:ext cx="5623560" cy="4978399"/>
          </a:xfrm>
        </p:spPr>
        <p:txBody>
          <a:bodyPr>
            <a:normAutofit/>
          </a:bodyPr>
          <a:lstStyle/>
          <a:p>
            <a:r>
              <a:rPr lang="en-US" sz="1800" dirty="0"/>
              <a:t> N(NH((</a:t>
            </a:r>
            <a:r>
              <a:rPr lang="en-US" sz="1800" dirty="0" err="1"/>
              <a:t>HEX&amp;phosphate</a:t>
            </a:r>
            <a:r>
              <a:rPr lang="en-US" sz="1800" dirty="0"/>
              <a:t>))(H(NH)(NH)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H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HH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acetyl&amp;sulfate</a:t>
            </a:r>
            <a:r>
              <a:rPr lang="en-US" sz="1800" dirty="0"/>
              <a:t>))(HN(</a:t>
            </a:r>
            <a:r>
              <a:rPr lang="en-US" sz="1800" dirty="0" err="1"/>
              <a:t>HEX&amp;sulfate</a:t>
            </a:r>
            <a:r>
              <a:rPr lang="en-US" sz="1800" dirty="0"/>
              <a:t>)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N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NH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n-acetyl&amp;sulfate</a:t>
            </a:r>
            <a:r>
              <a:rPr lang="en-US" sz="1800" dirty="0"/>
              <a:t>))(HNHS))(F)</a:t>
            </a:r>
          </a:p>
          <a:p>
            <a:r>
              <a:rPr lang="en-US" sz="1800" dirty="0"/>
              <a:t> N(NH(HN(</a:t>
            </a:r>
            <a:r>
              <a:rPr lang="en-US" sz="1800" dirty="0" err="1"/>
              <a:t>HEX&amp;sulfate</a:t>
            </a:r>
            <a:r>
              <a:rPr lang="en-US" sz="1800" dirty="0"/>
              <a:t>))(HNHS))(F)</a:t>
            </a:r>
          </a:p>
          <a:p>
            <a:r>
              <a:rPr lang="en-US" sz="1800" dirty="0"/>
              <a:t> N(NH(HNH)((</a:t>
            </a:r>
            <a:r>
              <a:rPr lang="en-US" sz="1800" dirty="0" err="1"/>
              <a:t>HEX&amp;phosphate</a:t>
            </a:r>
            <a:r>
              <a:rPr lang="en-US" sz="1800" dirty="0"/>
              <a:t>)))(F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694EB0D-E947-4AB7-AC6B-D7882281B46E}"/>
              </a:ext>
            </a:extLst>
          </p:cNvPr>
          <p:cNvSpPr/>
          <p:nvPr/>
        </p:nvSpPr>
        <p:spPr>
          <a:xfrm>
            <a:off x="6172200" y="1192726"/>
            <a:ext cx="5461000" cy="46198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NNH(H(NHS)(N(</a:t>
            </a:r>
            <a:r>
              <a:rPr lang="en-US" dirty="0" err="1"/>
              <a:t>HEX&amp;sulfate</a:t>
            </a:r>
            <a:r>
              <a:rPr lang="en-US" dirty="0"/>
              <a:t>)))(HNH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(</a:t>
            </a:r>
            <a:r>
              <a:rPr lang="en-US" dirty="0" err="1"/>
              <a:t>HEX&amp;n-acetyl&amp;sulfate</a:t>
            </a:r>
            <a:r>
              <a:rPr lang="en-US" dirty="0"/>
              <a:t>)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H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HS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sulfate</a:t>
            </a:r>
            <a:r>
              <a:rPr lang="en-US" dirty="0"/>
              <a:t>))(HNHS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H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N(NH(HNHNH(</a:t>
            </a:r>
            <a:r>
              <a:rPr lang="en-US" dirty="0" err="1"/>
              <a:t>NON|a|keto|d&amp;amino</a:t>
            </a:r>
            <a:r>
              <a:rPr lang="en-US" dirty="0"/>
              <a:t>))(HN(F)(H)))(F)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N(NH(HNHNH(</a:t>
            </a:r>
            <a:r>
              <a:rPr lang="en-US" dirty="0" err="1"/>
              <a:t>NON|a|keto|d</a:t>
            </a:r>
            <a:r>
              <a:rPr lang="en-US" dirty="0"/>
              <a:t>))(HN(F)(H)))(F)</a:t>
            </a:r>
          </a:p>
        </p:txBody>
      </p:sp>
    </p:spTree>
    <p:extLst>
      <p:ext uri="{BB962C8B-B14F-4D97-AF65-F5344CB8AC3E}">
        <p14:creationId xmlns:p14="http://schemas.microsoft.com/office/powerpoint/2010/main" val="15552543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8973AE-B7D4-4E21-852A-A4B2446CC2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H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ABBFE4F-ED7A-467D-8BE0-29B18A039D0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6050" t="17654" r="2006" b="16103"/>
          <a:stretch/>
        </p:blipFill>
        <p:spPr>
          <a:xfrm>
            <a:off x="1087120" y="1483359"/>
            <a:ext cx="9875520" cy="51146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8611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634D4-F728-4FFF-AC54-8BD9CAD1D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(NH(HN(</a:t>
            </a:r>
            <a:r>
              <a:rPr lang="en-US" dirty="0" err="1"/>
              <a:t>HEX&amp;n-acetyl&amp;sulfate</a:t>
            </a:r>
            <a:r>
              <a:rPr lang="en-US" dirty="0"/>
              <a:t>))(HHH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B6EF01A-9D25-40ED-88BE-F1E24B62542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965" t="17819" r="616" b="16571"/>
          <a:stretch/>
        </p:blipFill>
        <p:spPr>
          <a:xfrm>
            <a:off x="1089660" y="1548448"/>
            <a:ext cx="10012680" cy="50332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62068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D3B0E-8B70-42D5-89AE-33BA5E881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(</a:t>
            </a:r>
            <a:r>
              <a:rPr lang="en-US" dirty="0" err="1"/>
              <a:t>HEX&amp;n-acetyl&amp;sulfate</a:t>
            </a:r>
            <a:r>
              <a:rPr lang="en-US" dirty="0"/>
              <a:t>)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BB75F82-D966-4FBD-B8C0-88990D047F1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965" t="18986" r="1799" b="15870"/>
          <a:stretch/>
        </p:blipFill>
        <p:spPr>
          <a:xfrm>
            <a:off x="1417320" y="1898540"/>
            <a:ext cx="9357360" cy="4746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51780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ACBB3C-1BC7-4AAC-ADAF-63592E25D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(NH(HN(</a:t>
            </a:r>
            <a:r>
              <a:rPr lang="en-US" dirty="0" err="1"/>
              <a:t>HEX&amp;n-acetyl&amp;sulfate</a:t>
            </a:r>
            <a:r>
              <a:rPr lang="en-US" dirty="0"/>
              <a:t>))(HNH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805DDF7-D271-465A-AE9E-F6E0747B2EA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571" t="17352" r="1799" b="16804"/>
          <a:stretch/>
        </p:blipFill>
        <p:spPr>
          <a:xfrm>
            <a:off x="975360" y="1554479"/>
            <a:ext cx="9489440" cy="4839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81665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C4170-93EE-4537-B380-5F073E0DB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600" dirty="0"/>
              <a:t> N(NH(HN(</a:t>
            </a:r>
            <a:r>
              <a:rPr lang="en-US" sz="3600" dirty="0" err="1"/>
              <a:t>HEX&amp;n-acetyl&amp;sulfate</a:t>
            </a:r>
            <a:r>
              <a:rPr lang="en-US" sz="3600" dirty="0"/>
              <a:t>))(HN(</a:t>
            </a:r>
            <a:r>
              <a:rPr lang="en-US" sz="3600" dirty="0" err="1"/>
              <a:t>HEX&amp;sulfate</a:t>
            </a:r>
            <a:r>
              <a:rPr lang="en-US" sz="3600" dirty="0"/>
              <a:t>)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0D30349-C46F-4035-BA9A-43A14B5D219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6096" t="17819" r="92" b="16804"/>
          <a:stretch/>
        </p:blipFill>
        <p:spPr>
          <a:xfrm>
            <a:off x="1452880" y="1690688"/>
            <a:ext cx="8575040" cy="4272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864027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596E2-5D5E-49EA-AE68-3BCA059C41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NH(HN(</a:t>
            </a:r>
            <a:r>
              <a:rPr lang="en-US" dirty="0" err="1"/>
              <a:t>HEX&amp;sulfate</a:t>
            </a:r>
            <a:r>
              <a:rPr lang="en-US" dirty="0"/>
              <a:t>))(HNHS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77852E99-6A19-47A4-B137-ABFF94BEFF0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6097" t="17118" b="16103"/>
          <a:stretch/>
        </p:blipFill>
        <p:spPr>
          <a:xfrm>
            <a:off x="1351280" y="1772919"/>
            <a:ext cx="8940800" cy="45443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210848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0AE85-81F9-4BAB-A111-6F51585E5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 N(NH(HN(</a:t>
            </a:r>
            <a:r>
              <a:rPr lang="en-US" sz="2800" dirty="0" err="1"/>
              <a:t>HEX&amp;n-acetyl&amp;sulfate</a:t>
            </a:r>
            <a:r>
              <a:rPr lang="en-US" sz="2800" dirty="0"/>
              <a:t>))(HN(</a:t>
            </a:r>
            <a:r>
              <a:rPr lang="en-US" sz="2800" dirty="0" err="1"/>
              <a:t>HEX&amp;n-acetyl&amp;sulfate</a:t>
            </a:r>
            <a:r>
              <a:rPr lang="en-US" sz="2800" dirty="0"/>
              <a:t>)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29EDC2D-5452-457D-83AF-A55AAC955E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834" t="17586" b="16103"/>
          <a:stretch/>
        </p:blipFill>
        <p:spPr>
          <a:xfrm>
            <a:off x="1036320" y="1442719"/>
            <a:ext cx="9469120" cy="47622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53038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9A449-F7B1-4883-B533-32E83EDD1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HS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C133D4A-FE89-4A47-BD5F-8CC86B7942B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834" t="17819" b="16337"/>
          <a:stretch/>
        </p:blipFill>
        <p:spPr>
          <a:xfrm>
            <a:off x="944880" y="1690688"/>
            <a:ext cx="9408160" cy="4698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240841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F29623-70F3-43F9-8981-B1CAC47C2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/>
              <a:t>N(NH((HEX&amp;phosphate))(H(NH)(NH)))(F)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AF818-E98A-41E8-A6D2-87CDB526B0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MW 2051.68</a:t>
            </a:r>
          </a:p>
        </p:txBody>
      </p:sp>
    </p:spTree>
    <p:extLst>
      <p:ext uri="{BB962C8B-B14F-4D97-AF65-F5344CB8AC3E}">
        <p14:creationId xmlns:p14="http://schemas.microsoft.com/office/powerpoint/2010/main" val="379438581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686EE-D8B3-4415-A44F-8E3C06B77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(NH(HNH)((</a:t>
            </a:r>
            <a:r>
              <a:rPr lang="en-US" dirty="0" err="1"/>
              <a:t>HEX&amp;phosphate</a:t>
            </a:r>
            <a:r>
              <a:rPr lang="en-US" dirty="0"/>
              <a:t>)))(F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FD3770-3E32-4909-AD2A-42304311FA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MW 1686.55</a:t>
            </a:r>
          </a:p>
        </p:txBody>
      </p:sp>
    </p:spTree>
    <p:extLst>
      <p:ext uri="{BB962C8B-B14F-4D97-AF65-F5344CB8AC3E}">
        <p14:creationId xmlns:p14="http://schemas.microsoft.com/office/powerpoint/2010/main" val="323282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5C988-6BA1-4118-A417-DAC20807B6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 N-glycans containing NGNA (Hex-</a:t>
            </a:r>
            <a:r>
              <a:rPr lang="en-US" dirty="0" err="1"/>
              <a:t>HexNAc</a:t>
            </a:r>
            <a:r>
              <a:rPr lang="en-US" dirty="0"/>
              <a:t>-NANA-NGNA-</a:t>
            </a:r>
            <a:r>
              <a:rPr lang="en-US" dirty="0" err="1"/>
              <a:t>Fuc</a:t>
            </a:r>
            <a:r>
              <a:rPr lang="en-US" dirty="0"/>
              <a:t>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0EC463-6CF2-4681-ADE4-C4C7C1C70A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4-3-0-1-0</a:t>
            </a:r>
          </a:p>
          <a:p>
            <a:r>
              <a:rPr lang="en-US" dirty="0"/>
              <a:t>4-3-0-1-1</a:t>
            </a:r>
          </a:p>
          <a:p>
            <a:r>
              <a:rPr lang="en-US" dirty="0"/>
              <a:t>5-4-0-1-1</a:t>
            </a:r>
          </a:p>
          <a:p>
            <a:r>
              <a:rPr lang="en-US" dirty="0"/>
              <a:t>5-4-0-2-1</a:t>
            </a:r>
          </a:p>
          <a:p>
            <a:r>
              <a:rPr lang="en-US" dirty="0"/>
              <a:t>5-4-1-1-1</a:t>
            </a:r>
          </a:p>
          <a:p>
            <a:r>
              <a:rPr lang="en-US" dirty="0"/>
              <a:t>7-6-0-4-1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439687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3B6DB-CF6C-4FC7-9805-B5416545B9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39321"/>
          </a:xfrm>
        </p:spPr>
        <p:txBody>
          <a:bodyPr/>
          <a:lstStyle/>
          <a:p>
            <a:r>
              <a:rPr lang="en-US" dirty="0"/>
              <a:t> N(NH(HN(</a:t>
            </a:r>
            <a:r>
              <a:rPr lang="en-US" dirty="0" err="1"/>
              <a:t>HEX&amp;sulfate</a:t>
            </a:r>
            <a:r>
              <a:rPr lang="en-US" dirty="0"/>
              <a:t>))(HNHS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41B96BCD-D5FD-4311-9DEC-C0C668DF23C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3865" t="19219" r="19791" b="19372"/>
          <a:stretch/>
        </p:blipFill>
        <p:spPr>
          <a:xfrm>
            <a:off x="1930400" y="1204446"/>
            <a:ext cx="8757920" cy="5369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891880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AE13A-3EB8-4B29-A6A6-999401646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(NH(HN(</a:t>
            </a:r>
            <a:r>
              <a:rPr lang="en-US" dirty="0" err="1"/>
              <a:t>HEX&amp;n-acetyl&amp;sulfate</a:t>
            </a:r>
            <a:r>
              <a:rPr lang="en-US" dirty="0"/>
              <a:t>))(HNHS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D743017-8EA3-41A7-A3AC-9391ECE4C82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1893" t="17118" r="9022" b="21707"/>
          <a:stretch/>
        </p:blipFill>
        <p:spPr>
          <a:xfrm>
            <a:off x="1026160" y="1869439"/>
            <a:ext cx="9469120" cy="4716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486427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6951D-A2A6-4401-B9E5-8D4B8AF15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/>
              <a:t> NNH(H(NHS)(N(HEX&amp;sulfate)))(HNH)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37D7D6DB-DD4D-4907-98E8-7B23FE04B4B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682" t="14316" r="6527" b="21240"/>
          <a:stretch/>
        </p:blipFill>
        <p:spPr>
          <a:xfrm>
            <a:off x="1209040" y="1786550"/>
            <a:ext cx="9032240" cy="4625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434804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C05FDD-07E1-4B1C-8323-3F429861B4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(NH(HNHNH(</a:t>
            </a:r>
            <a:r>
              <a:rPr lang="en-US" dirty="0" err="1"/>
              <a:t>NON|a|keto|d</a:t>
            </a:r>
            <a:r>
              <a:rPr lang="en-US" dirty="0"/>
              <a:t>))(HN(F)(H)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B1D993A-5CBC-4E11-BF79-28EC465395E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4521" t="18285" r="19661" b="19840"/>
          <a:stretch/>
        </p:blipFill>
        <p:spPr>
          <a:xfrm>
            <a:off x="1696720" y="1469171"/>
            <a:ext cx="8056880" cy="5023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41334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F7446-447C-4628-9F05-AE0FCCFC76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600" dirty="0"/>
              <a:t>N(NH(HNHNH(</a:t>
            </a:r>
            <a:r>
              <a:rPr lang="en-US" sz="3600" dirty="0" err="1"/>
              <a:t>NON|a|keto|d&amp;amino</a:t>
            </a:r>
            <a:r>
              <a:rPr lang="en-US" sz="3600" dirty="0"/>
              <a:t>))(HN(F)(H)))(F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5A4D2E-2CAD-42A3-BFF6-1A0E14002B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459865"/>
            <a:ext cx="11242040" cy="4351338"/>
          </a:xfrm>
        </p:spPr>
        <p:txBody>
          <a:bodyPr/>
          <a:lstStyle/>
          <a:p>
            <a:r>
              <a:rPr lang="en-US" dirty="0"/>
              <a:t>MW 2544.91</a:t>
            </a:r>
          </a:p>
          <a:p>
            <a:r>
              <a:rPr lang="en-US" dirty="0"/>
              <a:t>Not found in </a:t>
            </a:r>
            <a:r>
              <a:rPr lang="en-US" dirty="0" err="1"/>
              <a:t>GlycomeDB</a:t>
            </a:r>
            <a:r>
              <a:rPr lang="en-US" dirty="0"/>
              <a:t>, but a glycan with close mass is found as below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A158C2D-8CBC-433D-9455-547396650E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917" t="18247" r="19583" b="20123"/>
          <a:stretch/>
        </p:blipFill>
        <p:spPr>
          <a:xfrm>
            <a:off x="944880" y="2407920"/>
            <a:ext cx="6766560" cy="4226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640839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8AAA7-AFA6-452B-8B83-079373B393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Hex4HexNAc3NGNA1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870E64B-A37C-484B-982B-D51D2D4D684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b="16103"/>
          <a:stretch/>
        </p:blipFill>
        <p:spPr>
          <a:xfrm>
            <a:off x="502920" y="1530383"/>
            <a:ext cx="10515600" cy="49624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19897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D38C6A-C9DA-4170-A15C-5F2F2640D1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/>
              <a:t> Hex4HexNAc3NGNA1Fuc1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80DF5050-1526-49A0-8130-29B2DAD64DB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571" t="14783" b="16571"/>
          <a:stretch/>
        </p:blipFill>
        <p:spPr>
          <a:xfrm>
            <a:off x="955040" y="1534159"/>
            <a:ext cx="9184640" cy="4764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824587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3E2F2-6544-4EA8-AADB-FEAA087294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5HexNAc4NGNA1Fuc1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F3BE1D15-98A0-4742-81BE-4514387DE1B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702" t="17819" r="1930" b="16571"/>
          <a:stretch/>
        </p:blipFill>
        <p:spPr>
          <a:xfrm>
            <a:off x="1137920" y="1690688"/>
            <a:ext cx="9448800" cy="4818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886244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C8A07E-308D-41DE-85D6-A89B01852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0680" y="233045"/>
            <a:ext cx="11638280" cy="1325563"/>
          </a:xfrm>
        </p:spPr>
        <p:txBody>
          <a:bodyPr>
            <a:noAutofit/>
          </a:bodyPr>
          <a:lstStyle/>
          <a:p>
            <a:r>
              <a:rPr lang="pt-BR" sz="3600" dirty="0"/>
              <a:t> Hex5HexNAc4NGNA2Fuc1 (not in glycomeDB or 701, in 197)</a:t>
            </a:r>
            <a:br>
              <a:rPr lang="pt-BR" sz="3600" dirty="0"/>
            </a:br>
            <a:r>
              <a:rPr lang="pt-BR" sz="3600" dirty="0"/>
              <a:t>Below is an isomeric structure from other species</a:t>
            </a:r>
            <a:endParaRPr lang="en-US" sz="3600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F6BB3B46-0EE3-474A-BE1F-080C6DBDD35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551" t="16884" r="7183" b="21240"/>
          <a:stretch/>
        </p:blipFill>
        <p:spPr>
          <a:xfrm>
            <a:off x="1117600" y="1964837"/>
            <a:ext cx="9408160" cy="4660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939705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2E6B0A-F246-4EF0-9C45-251C65DAE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5HexNAc4NANA1NGNA1Fuc1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B0CCDF97-9CF9-4428-A35A-30265668FEA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813" t="17118" r="6789" b="21240"/>
          <a:stretch/>
        </p:blipFill>
        <p:spPr>
          <a:xfrm>
            <a:off x="955040" y="1570672"/>
            <a:ext cx="9530080" cy="4693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76584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E4BCC-0D53-4A2D-A6A7-681CDA0BD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1079480" cy="1325563"/>
          </a:xfrm>
        </p:spPr>
        <p:txBody>
          <a:bodyPr/>
          <a:lstStyle/>
          <a:p>
            <a:r>
              <a:rPr lang="en-US" dirty="0"/>
              <a:t>11 unmodified N-glycans not in N701 database (Hex-</a:t>
            </a:r>
            <a:r>
              <a:rPr lang="en-US" dirty="0" err="1"/>
              <a:t>HexNAc</a:t>
            </a:r>
            <a:r>
              <a:rPr lang="en-US" dirty="0"/>
              <a:t>-NANA-NGNA-</a:t>
            </a:r>
            <a:r>
              <a:rPr lang="en-US" dirty="0" err="1"/>
              <a:t>Fuc</a:t>
            </a:r>
            <a:r>
              <a:rPr lang="en-US" dirty="0"/>
              <a:t>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28C957-6CE1-4A1F-A22A-7421FED188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4"/>
            <a:ext cx="11079480" cy="4778376"/>
          </a:xfrm>
        </p:spPr>
        <p:txBody>
          <a:bodyPr>
            <a:normAutofit fontScale="92500" lnSpcReduction="20000"/>
          </a:bodyPr>
          <a:lstStyle/>
          <a:p>
            <a:r>
              <a:rPr lang="en-US" dirty="0">
                <a:solidFill>
                  <a:srgbClr val="FF0000"/>
                </a:solidFill>
              </a:rPr>
              <a:t>3-6-1-0-1</a:t>
            </a:r>
          </a:p>
          <a:p>
            <a:r>
              <a:rPr lang="en-US" dirty="0">
                <a:solidFill>
                  <a:srgbClr val="FF0000"/>
                </a:solidFill>
              </a:rPr>
              <a:t>3-6-1-0-2</a:t>
            </a:r>
          </a:p>
          <a:p>
            <a:r>
              <a:rPr lang="en-US" dirty="0">
                <a:solidFill>
                  <a:srgbClr val="FF0000"/>
                </a:solidFill>
              </a:rPr>
              <a:t>3-6-2-0-1</a:t>
            </a:r>
          </a:p>
          <a:p>
            <a:r>
              <a:rPr lang="en-US" dirty="0">
                <a:solidFill>
                  <a:srgbClr val="FF0000"/>
                </a:solidFill>
              </a:rPr>
              <a:t>3-8-0-0-1</a:t>
            </a:r>
          </a:p>
          <a:p>
            <a:r>
              <a:rPr lang="en-US" dirty="0">
                <a:solidFill>
                  <a:srgbClr val="FF0000"/>
                </a:solidFill>
              </a:rPr>
              <a:t>3-9-0-0-0</a:t>
            </a:r>
          </a:p>
          <a:p>
            <a:r>
              <a:rPr lang="en-US" dirty="0">
                <a:solidFill>
                  <a:srgbClr val="FF0000"/>
                </a:solidFill>
              </a:rPr>
              <a:t>3-9-0-0-1</a:t>
            </a:r>
          </a:p>
          <a:p>
            <a:r>
              <a:rPr lang="en-US" dirty="0">
                <a:solidFill>
                  <a:srgbClr val="FF0000"/>
                </a:solidFill>
              </a:rPr>
              <a:t>4-9-0-0-0</a:t>
            </a:r>
          </a:p>
          <a:p>
            <a:r>
              <a:rPr lang="en-US" dirty="0">
                <a:solidFill>
                  <a:srgbClr val="FF0000"/>
                </a:solidFill>
              </a:rPr>
              <a:t>4-9-0-0-1</a:t>
            </a:r>
          </a:p>
          <a:p>
            <a:r>
              <a:rPr lang="en-US" dirty="0">
                <a:solidFill>
                  <a:srgbClr val="FF0000"/>
                </a:solidFill>
              </a:rPr>
              <a:t>5-6-3-0-1</a:t>
            </a:r>
          </a:p>
          <a:p>
            <a:r>
              <a:rPr lang="en-US" dirty="0">
                <a:solidFill>
                  <a:srgbClr val="FF0000"/>
                </a:solidFill>
              </a:rPr>
              <a:t>7-10-4-0-1</a:t>
            </a:r>
          </a:p>
          <a:p>
            <a:r>
              <a:rPr lang="en-US" dirty="0">
                <a:solidFill>
                  <a:srgbClr val="FF0000"/>
                </a:solidFill>
              </a:rPr>
              <a:t>7-9-4-0-1</a:t>
            </a:r>
          </a:p>
        </p:txBody>
      </p:sp>
    </p:spTree>
    <p:extLst>
      <p:ext uri="{BB962C8B-B14F-4D97-AF65-F5344CB8AC3E}">
        <p14:creationId xmlns:p14="http://schemas.microsoft.com/office/powerpoint/2010/main" val="142584621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29475-C957-4DA6-9812-DF6C0621D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7HexNAc6NGNA4Fuc1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1861478-5BA1-4B28-974C-23BE7D1C212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4783" t="18519" r="19792" b="19372"/>
          <a:stretch/>
        </p:blipFill>
        <p:spPr>
          <a:xfrm>
            <a:off x="1356360" y="1519871"/>
            <a:ext cx="7828280" cy="49344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233600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0934A-91AC-4CC3-9962-F167F92227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3HexNAc6NANA1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B88D4B19-6E3B-4397-8F3D-33D6C57AFB1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965" t="17819" b="17038"/>
          <a:stretch/>
        </p:blipFill>
        <p:spPr>
          <a:xfrm>
            <a:off x="838200" y="1839594"/>
            <a:ext cx="9401534" cy="4653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043135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369CA2-AB30-4D3D-848B-FD4FFCE6A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3HexNAc6NANA1Fuc2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13B44A3-F8CC-47F7-B348-2F9CE6E2C0F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813" t="16884" r="6657" b="21240"/>
          <a:stretch/>
        </p:blipFill>
        <p:spPr>
          <a:xfrm>
            <a:off x="934720" y="1873568"/>
            <a:ext cx="9839960" cy="4855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987850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1684B-0F76-4C62-83A0-41C440F03E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3HexNAc6NANA2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FE8E9B59-A85C-4CE7-AE9F-044F1FBD0E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813" t="16884" r="7052" b="21240"/>
          <a:stretch/>
        </p:blipFill>
        <p:spPr>
          <a:xfrm>
            <a:off x="924560" y="1554479"/>
            <a:ext cx="10200640" cy="50621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129643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2DF87-A210-46F6-8D21-305ACA1D1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3HexNAc8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93D7A0B-D227-4EB3-B7C7-6026B90704B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551" t="16884" r="7708" b="21941"/>
          <a:stretch/>
        </p:blipFill>
        <p:spPr>
          <a:xfrm>
            <a:off x="1056640" y="1767839"/>
            <a:ext cx="9560560" cy="4717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292080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70A6F-D357-459E-9C29-C7F829D0EE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3HexNAc9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9A7080C-3D9F-4826-BE23-9EEB819EC33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3338" t="15651" r="6658" b="21474"/>
          <a:stretch/>
        </p:blipFill>
        <p:spPr>
          <a:xfrm>
            <a:off x="924560" y="1571942"/>
            <a:ext cx="8432800" cy="4260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932036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3FB612-0E25-4666-B181-2E9B092D44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3HexNAc9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7561C74B-D5CA-44C9-898C-6463F92114A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551" t="16651" r="8891" b="21240"/>
          <a:stretch/>
        </p:blipFill>
        <p:spPr>
          <a:xfrm>
            <a:off x="1087120" y="1690688"/>
            <a:ext cx="8128000" cy="4141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2922222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12DFE-5CE8-4A11-B15E-0461E8858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4HexNAc9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2C9A35C-A4EF-48D6-8D35-3DE2ABD34DF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550" t="17118" r="9153" b="21473"/>
          <a:stretch/>
        </p:blipFill>
        <p:spPr>
          <a:xfrm>
            <a:off x="1160780" y="1500708"/>
            <a:ext cx="9870440" cy="49921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871796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323E6-15DE-4EC1-881B-C7DCE0E04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711835"/>
          </a:xfrm>
        </p:spPr>
        <p:txBody>
          <a:bodyPr/>
          <a:lstStyle/>
          <a:p>
            <a:r>
              <a:rPr lang="en-US" dirty="0"/>
              <a:t>Hex4HexNAc9Fuc1 (in 197, not in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752851A-64A5-4B6D-BDA9-8312AA3F273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4914" t="18052" r="19661" b="19839"/>
          <a:stretch/>
        </p:blipFill>
        <p:spPr>
          <a:xfrm>
            <a:off x="1381760" y="1209040"/>
            <a:ext cx="8554720" cy="5392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188016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0DFFE-0C75-47CD-B5BB-703E537324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5HexNAc6NANA3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DEB4916-8F4E-4268-A15D-C31E9C7C33E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046" t="18285" r="19792" b="19840"/>
          <a:stretch/>
        </p:blipFill>
        <p:spPr>
          <a:xfrm>
            <a:off x="1722120" y="1788159"/>
            <a:ext cx="7645400" cy="4823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122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A7B6C5-3F9A-4980-B23D-26A171786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/>
              <a:t> NNH(HN(HEX&amp;n-acetyl&amp;sulfate))(H) 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DFC1F8A-3580-41F2-BC5C-EF820F423A9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348" t="17979" r="-17968" b="11434"/>
          <a:stretch/>
        </p:blipFill>
        <p:spPr>
          <a:xfrm>
            <a:off x="965247" y="1690688"/>
            <a:ext cx="9778430" cy="41919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023853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8AB9B6-E237-4A37-844D-1733DE92E0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x6HexNAc6NANA1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1312CC60-1EE9-42DB-8828-035B5B349D4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046" t="18052" r="19792" b="19607"/>
          <a:stretch/>
        </p:blipFill>
        <p:spPr>
          <a:xfrm>
            <a:off x="1524000" y="1828799"/>
            <a:ext cx="7538720" cy="4792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99377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D7D1F-F1A6-448B-AE79-E74618B26E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2120" y="304165"/>
            <a:ext cx="10896600" cy="1325563"/>
          </a:xfrm>
        </p:spPr>
        <p:txBody>
          <a:bodyPr>
            <a:normAutofit/>
          </a:bodyPr>
          <a:lstStyle/>
          <a:p>
            <a:r>
              <a:rPr lang="pt-BR" dirty="0"/>
              <a:t> Hex7HexNAc9NANA4Fuc1 (in 197, not in 701)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B51CB681-EF58-4D68-A671-534138B767A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4652" t="18519" r="17428" b="19372"/>
          <a:stretch/>
        </p:blipFill>
        <p:spPr>
          <a:xfrm>
            <a:off x="1330960" y="1528128"/>
            <a:ext cx="8006080" cy="4829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9766217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988F4-4B83-45EE-9653-B174D134ED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977880" cy="1325563"/>
          </a:xfrm>
        </p:spPr>
        <p:txBody>
          <a:bodyPr/>
          <a:lstStyle/>
          <a:p>
            <a:r>
              <a:rPr lang="en-US" dirty="0"/>
              <a:t>Hex7HexNAc10NANA4Fuc1 (in 197, not in 701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4AA78200-1670-43D0-B1B2-C9ECA56C735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4258" t="18752" r="19923" b="19373"/>
          <a:stretch/>
        </p:blipFill>
        <p:spPr>
          <a:xfrm>
            <a:off x="944880" y="1446848"/>
            <a:ext cx="7457440" cy="46499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03546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21DE6-C5BD-42DC-8ED5-A538CCCA71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/>
              <a:t> N(NH(HN(HEX&amp;n-acetyl&amp;sulfate))(H))(F)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4EDD32B-12C1-4AAC-BC8C-BD5B316AFA1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4914" t="17819" r="19792" b="19139"/>
          <a:stretch/>
        </p:blipFill>
        <p:spPr>
          <a:xfrm>
            <a:off x="1838960" y="1545691"/>
            <a:ext cx="7569200" cy="4854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0957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75DA3E-D070-4CCB-9C3E-50890A32C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NH(HN(</a:t>
            </a:r>
            <a:r>
              <a:rPr lang="en-US" dirty="0" err="1"/>
              <a:t>HEX&amp;n-acetyl&amp;sulfate</a:t>
            </a:r>
            <a:r>
              <a:rPr lang="en-US" dirty="0"/>
              <a:t>))(HH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87A341B4-7E79-4829-9C47-659CA178049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834" t="17351" b="16570"/>
          <a:stretch/>
        </p:blipFill>
        <p:spPr>
          <a:xfrm>
            <a:off x="838200" y="1554479"/>
            <a:ext cx="9692640" cy="4857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41263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DC241-DEB6-4DA1-A260-A5834E2CD2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NH(HN(</a:t>
            </a:r>
            <a:r>
              <a:rPr lang="en-US" dirty="0" err="1"/>
              <a:t>HEX&amp;n-acetyl&amp;sulfate</a:t>
            </a:r>
            <a:r>
              <a:rPr lang="en-US" dirty="0"/>
              <a:t>))(HN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7833E61E-5A1F-4374-853F-0F1C9B14720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965" t="17585" b="16803"/>
          <a:stretch/>
        </p:blipFill>
        <p:spPr>
          <a:xfrm>
            <a:off x="838200" y="1371599"/>
            <a:ext cx="9128760" cy="45506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60369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05BD1-67A3-4337-99C5-6231031685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 N(NH(HN(</a:t>
            </a:r>
            <a:r>
              <a:rPr lang="en-US" dirty="0" err="1"/>
              <a:t>HEX&amp;n-acetyl&amp;sulfate</a:t>
            </a:r>
            <a:r>
              <a:rPr lang="en-US" dirty="0"/>
              <a:t>))(HH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3DD4F147-D796-442A-A4B6-0980CCAC94A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965" t="17819" r="-434" b="16104"/>
          <a:stretch/>
        </p:blipFill>
        <p:spPr>
          <a:xfrm>
            <a:off x="1097280" y="1665243"/>
            <a:ext cx="9672320" cy="4827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04629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D3C4B2-07EE-4BD9-ADBE-FFBAC9285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N(NH(HN(</a:t>
            </a:r>
            <a:r>
              <a:rPr lang="en-US" dirty="0" err="1"/>
              <a:t>HEX&amp;n-acetyl&amp;sulfate</a:t>
            </a:r>
            <a:r>
              <a:rPr lang="en-US" dirty="0"/>
              <a:t>))(HN))(F)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58AF0BF-98EA-41E2-94AF-168790F14C6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702" t="17819" r="92" b="17505"/>
          <a:stretch/>
        </p:blipFill>
        <p:spPr>
          <a:xfrm>
            <a:off x="1320800" y="1777999"/>
            <a:ext cx="9398000" cy="46075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358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0</TotalTime>
  <Words>876</Words>
  <Application>Microsoft Office PowerPoint</Application>
  <PresentationFormat>Widescreen</PresentationFormat>
  <Paragraphs>84</Paragraphs>
  <Slides>4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2</vt:i4>
      </vt:variant>
    </vt:vector>
  </HeadingPairs>
  <TitlesOfParts>
    <vt:vector size="46" baseType="lpstr">
      <vt:lpstr>Arial</vt:lpstr>
      <vt:lpstr>Calibri</vt:lpstr>
      <vt:lpstr>Calibri Light</vt:lpstr>
      <vt:lpstr>Office Theme</vt:lpstr>
      <vt:lpstr>21 Modified N-glycans</vt:lpstr>
      <vt:lpstr>6 N-glycans containing NGNA (Hex-HexNAc-NANA-NGNA-Fuc)</vt:lpstr>
      <vt:lpstr>11 unmodified N-glycans not in N701 database (Hex-HexNAc-NANA-NGNA-Fuc)</vt:lpstr>
      <vt:lpstr> NNH(HN(HEX&amp;n-acetyl&amp;sulfate))(H) </vt:lpstr>
      <vt:lpstr> N(NH(HN(HEX&amp;n-acetyl&amp;sulfate))(H))(F)</vt:lpstr>
      <vt:lpstr>NNH(HN(HEX&amp;n-acetyl&amp;sulfate))(HH)</vt:lpstr>
      <vt:lpstr> NNH(HN(HEX&amp;n-acetyl&amp;sulfate))(HN)</vt:lpstr>
      <vt:lpstr> N(NH(HN(HEX&amp;n-acetyl&amp;sulfate))(HH))(F)</vt:lpstr>
      <vt:lpstr> N(NH(HN(HEX&amp;n-acetyl&amp;sulfate))(HN))(F)</vt:lpstr>
      <vt:lpstr> NNH(HN(HEX&amp;n-acetyl&amp;sulfate))(HNH)</vt:lpstr>
      <vt:lpstr> N(NH(HN(HEX&amp;n-acetyl&amp;sulfate))(HHH))(F)</vt:lpstr>
      <vt:lpstr> NNH(HN(HEX&amp;n-acetyl&amp;sulfate))(HN(HEX&amp;n-acetyl&amp;sulfate))</vt:lpstr>
      <vt:lpstr> N(NH(HN(HEX&amp;n-acetyl&amp;sulfate))(HNH))(F)</vt:lpstr>
      <vt:lpstr> N(NH(HN(HEX&amp;n-acetyl&amp;sulfate))(HN(HEX&amp;sulfate)))(F)</vt:lpstr>
      <vt:lpstr> NNH(HN(HEX&amp;sulfate))(HNHS)</vt:lpstr>
      <vt:lpstr> N(NH(HN(HEX&amp;n-acetyl&amp;sulfate))(HN(HEX&amp;n-acetyl&amp;sulfate)))(F)</vt:lpstr>
      <vt:lpstr> NNH(HN(HEX&amp;n-acetyl&amp;sulfate))(HNHS)</vt:lpstr>
      <vt:lpstr>N(NH((HEX&amp;phosphate))(H(NH)(NH)))(F)</vt:lpstr>
      <vt:lpstr> N(NH(HNH)((HEX&amp;phosphate)))(F)</vt:lpstr>
      <vt:lpstr> N(NH(HN(HEX&amp;sulfate))(HNHS))(F)</vt:lpstr>
      <vt:lpstr> N(NH(HN(HEX&amp;n-acetyl&amp;sulfate))(HNHS))(F)</vt:lpstr>
      <vt:lpstr> NNH(H(NHS)(N(HEX&amp;sulfate)))(HNH)</vt:lpstr>
      <vt:lpstr>N(NH(HNHNH(NON|a|keto|d))(HN(F)(H)))(F)</vt:lpstr>
      <vt:lpstr>N(NH(HNHNH(NON|a|keto|d&amp;amino))(HN(F)(H)))(F)</vt:lpstr>
      <vt:lpstr> Hex4HexNAc3NGNA1</vt:lpstr>
      <vt:lpstr> Hex4HexNAc3NGNA1Fuc1</vt:lpstr>
      <vt:lpstr>Hex5HexNAc4NGNA1Fuc1</vt:lpstr>
      <vt:lpstr> Hex5HexNAc4NGNA2Fuc1 (not in glycomeDB or 701, in 197) Below is an isomeric structure from other species</vt:lpstr>
      <vt:lpstr>Hex5HexNAc4NANA1NGNA1Fuc1</vt:lpstr>
      <vt:lpstr>Hex7HexNAc6NGNA4Fuc1</vt:lpstr>
      <vt:lpstr>Hex3HexNAc6NANA1Fuc1 (in 197, not in 701)</vt:lpstr>
      <vt:lpstr>Hex3HexNAc6NANA1Fuc2 (in 197, not in 701)</vt:lpstr>
      <vt:lpstr>Hex3HexNAc6NANA2Fuc1 (in 197, not in 701)</vt:lpstr>
      <vt:lpstr>Hex3HexNAc8Fuc1 (in 197, not in 701)</vt:lpstr>
      <vt:lpstr>Hex3HexNAc9 (in 197, not in 701)</vt:lpstr>
      <vt:lpstr>Hex3HexNAc9Fuc1 (in 197, not in 701)</vt:lpstr>
      <vt:lpstr>Hex4HexNAc9 (in 197, not in 701)</vt:lpstr>
      <vt:lpstr>Hex4HexNAc9Fuc1 (in 197, not in701)</vt:lpstr>
      <vt:lpstr>Hex5HexNAc6NANA3Fuc1 (in 197, not in 701)</vt:lpstr>
      <vt:lpstr>Hex6HexNAc6NANA1Fuc1 (in 197, not in 701)</vt:lpstr>
      <vt:lpstr> Hex7HexNAc9NANA4Fuc1 (in 197, not in 701)</vt:lpstr>
      <vt:lpstr>Hex7HexNAc10NANA4Fuc1 (in 197, not in 701)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, Qingbo</dc:creator>
  <cp:lastModifiedBy>Shu, Qingbo</cp:lastModifiedBy>
  <cp:revision>35</cp:revision>
  <dcterms:created xsi:type="dcterms:W3CDTF">2019-08-13T16:28:24Z</dcterms:created>
  <dcterms:modified xsi:type="dcterms:W3CDTF">2019-08-23T20:08:25Z</dcterms:modified>
</cp:coreProperties>
</file>